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7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6" clrIdx="0"/>
  <p:cmAuthor id="2" name="Susan" initials="SH" lastIdx="7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23" autoAdjust="0"/>
    <p:restoredTop sz="99451" autoAdjust="0"/>
  </p:normalViewPr>
  <p:slideViewPr>
    <p:cSldViewPr snapToGrid="0">
      <p:cViewPr varScale="1">
        <p:scale>
          <a:sx n="47" d="100"/>
          <a:sy n="47" d="100"/>
        </p:scale>
        <p:origin x="2400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1-Luciferase%20assay%20methodology%20paper\Figure%20S4%20coculture%202D%20and%203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1-Luciferase%20assay%20methodology%20paper\Figure%20S4%20coculture%202D%20and%203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1-Luciferase%20assay%20methodology%20paper\Figure%20S4%20coculture%202D%20and%203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1-Luciferase%20assay%20methodology%20paper\Figure%20S4%20coculture%202D%20and%203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35597837336601"/>
          <c:y val="0.10625550660793"/>
          <c:w val="0.79537693435008405"/>
          <c:h val="0.757484477435915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HDFs</c:f>
              <c:strCache>
                <c:ptCount val="1"/>
                <c:pt idx="0">
                  <c:v>NHDFs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110'!$F$25:$F$28</c:f>
                <c:numCache>
                  <c:formatCode>General</c:formatCode>
                  <c:ptCount val="4"/>
                  <c:pt idx="0">
                    <c:v>3552.8767686669498</c:v>
                  </c:pt>
                  <c:pt idx="1">
                    <c:v>6939.3947862907999</c:v>
                  </c:pt>
                  <c:pt idx="2">
                    <c:v>10877.2300395521</c:v>
                  </c:pt>
                  <c:pt idx="3">
                    <c:v>49829.356809013698</c:v>
                  </c:pt>
                </c:numCache>
              </c:numRef>
            </c:plus>
            <c:minus>
              <c:numRef>
                <c:f>'B110'!$F$25:$F$28</c:f>
                <c:numCache>
                  <c:formatCode>General</c:formatCode>
                  <c:ptCount val="4"/>
                  <c:pt idx="0">
                    <c:v>3552.8767686669498</c:v>
                  </c:pt>
                  <c:pt idx="1">
                    <c:v>6939.3947862907999</c:v>
                  </c:pt>
                  <c:pt idx="2">
                    <c:v>10877.2300395521</c:v>
                  </c:pt>
                  <c:pt idx="3">
                    <c:v>49829.3568090136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numRef>
              <c:f>'B110'!$A$4:$A$7</c:f>
              <c:numCache>
                <c:formatCode>General</c:formatCode>
                <c:ptCount val="4"/>
                <c:pt idx="0">
                  <c:v>0</c:v>
                </c:pt>
                <c:pt idx="1">
                  <c:v>5000</c:v>
                </c:pt>
                <c:pt idx="2">
                  <c:v>10000</c:v>
                </c:pt>
                <c:pt idx="3">
                  <c:v>20000</c:v>
                </c:pt>
              </c:numCache>
            </c:numRef>
          </c:cat>
          <c:val>
            <c:numRef>
              <c:f>'B110'!$E$25:$E$28</c:f>
              <c:numCache>
                <c:formatCode>General</c:formatCode>
                <c:ptCount val="4"/>
                <c:pt idx="0">
                  <c:v>160453.33333333299</c:v>
                </c:pt>
                <c:pt idx="1">
                  <c:v>258520</c:v>
                </c:pt>
                <c:pt idx="2">
                  <c:v>286146.66666666698</c:v>
                </c:pt>
                <c:pt idx="3">
                  <c:v>3757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E5-48E6-ABEA-5E5F22DC8700}"/>
            </c:ext>
          </c:extLst>
        </c:ser>
        <c:ser>
          <c:idx val="1"/>
          <c:order val="1"/>
          <c:tx>
            <c:strRef>
              <c:f>PBMCs</c:f>
              <c:strCache>
                <c:ptCount val="1"/>
                <c:pt idx="0">
                  <c:v>PBMCs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110'!$L$25:$L$28</c:f>
                <c:numCache>
                  <c:formatCode>General</c:formatCode>
                  <c:ptCount val="4"/>
                  <c:pt idx="0">
                    <c:v>3552.8767686669498</c:v>
                  </c:pt>
                  <c:pt idx="1">
                    <c:v>4509.2497528228696</c:v>
                  </c:pt>
                  <c:pt idx="2">
                    <c:v>4138.6632302391299</c:v>
                  </c:pt>
                  <c:pt idx="3">
                    <c:v>7430.9981384288703</c:v>
                  </c:pt>
                </c:numCache>
              </c:numRef>
            </c:plus>
            <c:minus>
              <c:numRef>
                <c:f>'B110'!$L$25:$L$28</c:f>
                <c:numCache>
                  <c:formatCode>General</c:formatCode>
                  <c:ptCount val="4"/>
                  <c:pt idx="0">
                    <c:v>3552.8767686669498</c:v>
                  </c:pt>
                  <c:pt idx="1">
                    <c:v>4509.2497528228696</c:v>
                  </c:pt>
                  <c:pt idx="2">
                    <c:v>4138.6632302391299</c:v>
                  </c:pt>
                  <c:pt idx="3">
                    <c:v>7430.99813842887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val>
            <c:numRef>
              <c:f>'B110'!$K$25:$K$28</c:f>
              <c:numCache>
                <c:formatCode>General</c:formatCode>
                <c:ptCount val="4"/>
                <c:pt idx="0">
                  <c:v>160453.33333333299</c:v>
                </c:pt>
                <c:pt idx="1">
                  <c:v>172373.33333333299</c:v>
                </c:pt>
                <c:pt idx="2">
                  <c:v>179186.66666666701</c:v>
                </c:pt>
                <c:pt idx="3">
                  <c:v>186266.66666666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DE5-48E6-ABEA-5E5F22DC87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6196664"/>
        <c:axId val="145012432"/>
      </c:barChart>
      <c:catAx>
        <c:axId val="6196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012432"/>
        <c:crosses val="autoZero"/>
        <c:auto val="1"/>
        <c:lblAlgn val="ctr"/>
        <c:lblOffset val="100"/>
        <c:noMultiLvlLbl val="0"/>
      </c:catAx>
      <c:valAx>
        <c:axId val="145012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66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7388802770473097"/>
          <c:y val="7.8311020597839606E-2"/>
          <c:w val="0.62360092753479002"/>
          <c:h val="0.116007261206886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sz="9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35597837336601"/>
          <c:y val="0.10625550660793"/>
          <c:w val="0.79537693435008405"/>
          <c:h val="0.7348594321292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HDFs</c:f>
              <c:strCache>
                <c:ptCount val="1"/>
                <c:pt idx="0">
                  <c:v>NHDFs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110'!$F$4:$F$7</c:f>
                <c:numCache>
                  <c:formatCode>General</c:formatCode>
                  <c:ptCount val="4"/>
                  <c:pt idx="0">
                    <c:v>1422.8609676751</c:v>
                  </c:pt>
                  <c:pt idx="1">
                    <c:v>1710.82825945018</c:v>
                  </c:pt>
                  <c:pt idx="2">
                    <c:v>1737.2775636993999</c:v>
                  </c:pt>
                  <c:pt idx="3">
                    <c:v>1972.74766083585</c:v>
                  </c:pt>
                </c:numCache>
              </c:numRef>
            </c:plus>
            <c:minus>
              <c:numRef>
                <c:f>'B110'!$F$4:$F$7</c:f>
                <c:numCache>
                  <c:formatCode>General</c:formatCode>
                  <c:ptCount val="4"/>
                  <c:pt idx="0">
                    <c:v>1422.8609676751</c:v>
                  </c:pt>
                  <c:pt idx="1">
                    <c:v>1710.82825945018</c:v>
                  </c:pt>
                  <c:pt idx="2">
                    <c:v>1737.2775636993999</c:v>
                  </c:pt>
                  <c:pt idx="3">
                    <c:v>1972.747660835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numRef>
              <c:f>'B110'!$A$4:$A$7</c:f>
              <c:numCache>
                <c:formatCode>General</c:formatCode>
                <c:ptCount val="4"/>
                <c:pt idx="0">
                  <c:v>0</c:v>
                </c:pt>
                <c:pt idx="1">
                  <c:v>5000</c:v>
                </c:pt>
                <c:pt idx="2">
                  <c:v>10000</c:v>
                </c:pt>
                <c:pt idx="3">
                  <c:v>20000</c:v>
                </c:pt>
              </c:numCache>
            </c:numRef>
          </c:cat>
          <c:val>
            <c:numRef>
              <c:f>'B110'!$E$4:$E$7</c:f>
              <c:numCache>
                <c:formatCode>General</c:formatCode>
                <c:ptCount val="4"/>
                <c:pt idx="0">
                  <c:v>24386.666666666701</c:v>
                </c:pt>
                <c:pt idx="1">
                  <c:v>37506.666666666599</c:v>
                </c:pt>
                <c:pt idx="2">
                  <c:v>37253.333333333299</c:v>
                </c:pt>
                <c:pt idx="3">
                  <c:v>49746.6666666665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C5-45FE-A4DF-263D920F53B3}"/>
            </c:ext>
          </c:extLst>
        </c:ser>
        <c:ser>
          <c:idx val="1"/>
          <c:order val="1"/>
          <c:tx>
            <c:strRef>
              <c:f>PBMCs</c:f>
              <c:strCache>
                <c:ptCount val="1"/>
                <c:pt idx="0">
                  <c:v>PBMC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110'!$L$4:$L$7</c:f>
                <c:numCache>
                  <c:formatCode>General</c:formatCode>
                  <c:ptCount val="4"/>
                  <c:pt idx="0">
                    <c:v>1422.8609676751</c:v>
                  </c:pt>
                  <c:pt idx="1">
                    <c:v>4966.6085007779902</c:v>
                  </c:pt>
                  <c:pt idx="2">
                    <c:v>4713.8943560500002</c:v>
                  </c:pt>
                  <c:pt idx="3">
                    <c:v>5020.3319943339902</c:v>
                  </c:pt>
                </c:numCache>
              </c:numRef>
            </c:plus>
            <c:minus>
              <c:numRef>
                <c:f>'B110'!$L$4:$L$7</c:f>
                <c:numCache>
                  <c:formatCode>General</c:formatCode>
                  <c:ptCount val="4"/>
                  <c:pt idx="0">
                    <c:v>1422.8609676751</c:v>
                  </c:pt>
                  <c:pt idx="1">
                    <c:v>4966.6085007779902</c:v>
                  </c:pt>
                  <c:pt idx="2">
                    <c:v>4713.8943560500002</c:v>
                  </c:pt>
                  <c:pt idx="3">
                    <c:v>5020.33199433399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val>
            <c:numRef>
              <c:f>'B110'!$K$4:$K$7</c:f>
              <c:numCache>
                <c:formatCode>General</c:formatCode>
                <c:ptCount val="4"/>
                <c:pt idx="0">
                  <c:v>24386.666666666701</c:v>
                </c:pt>
                <c:pt idx="1">
                  <c:v>22480</c:v>
                </c:pt>
                <c:pt idx="2">
                  <c:v>27640</c:v>
                </c:pt>
                <c:pt idx="3">
                  <c:v>31786.666666666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EC5-45FE-A4DF-263D920F53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22374496"/>
        <c:axId val="147188744"/>
      </c:barChart>
      <c:catAx>
        <c:axId val="122374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7188744"/>
        <c:crosses val="autoZero"/>
        <c:auto val="1"/>
        <c:lblAlgn val="ctr"/>
        <c:lblOffset val="100"/>
        <c:noMultiLvlLbl val="0"/>
      </c:catAx>
      <c:valAx>
        <c:axId val="147188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2374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sz="9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35597837336601"/>
          <c:y val="0.13607692465739399"/>
          <c:w val="0.79537693435008405"/>
          <c:h val="0.668020557856398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HDFs</c:f>
              <c:strCache>
                <c:ptCount val="1"/>
                <c:pt idx="0">
                  <c:v>NHDFs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84'!$G$8:$G$11</c:f>
                <c:numCache>
                  <c:formatCode>General</c:formatCode>
                  <c:ptCount val="4"/>
                  <c:pt idx="0">
                    <c:v>262.29754097207802</c:v>
                  </c:pt>
                  <c:pt idx="1">
                    <c:v>706.91819422994899</c:v>
                  </c:pt>
                  <c:pt idx="2">
                    <c:v>876.60329301989998</c:v>
                  </c:pt>
                  <c:pt idx="3">
                    <c:v>1165.73295970104</c:v>
                  </c:pt>
                </c:numCache>
              </c:numRef>
            </c:plus>
            <c:minus>
              <c:numRef>
                <c:f>'284'!$G$8:$G$11</c:f>
                <c:numCache>
                  <c:formatCode>General</c:formatCode>
                  <c:ptCount val="4"/>
                  <c:pt idx="0">
                    <c:v>262.29754097207802</c:v>
                  </c:pt>
                  <c:pt idx="1">
                    <c:v>706.91819422994899</c:v>
                  </c:pt>
                  <c:pt idx="2">
                    <c:v>876.60329301989998</c:v>
                  </c:pt>
                  <c:pt idx="3">
                    <c:v>1165.73295970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'284'!$B$8:$B$11</c:f>
              <c:numCache>
                <c:formatCode>General</c:formatCode>
                <c:ptCount val="4"/>
                <c:pt idx="0">
                  <c:v>0</c:v>
                </c:pt>
                <c:pt idx="1">
                  <c:v>5000</c:v>
                </c:pt>
                <c:pt idx="2">
                  <c:v>10000</c:v>
                </c:pt>
                <c:pt idx="3">
                  <c:v>20000</c:v>
                </c:pt>
              </c:numCache>
            </c:numRef>
          </c:cat>
          <c:val>
            <c:numRef>
              <c:f>'284'!$F$8:$F$11</c:f>
              <c:numCache>
                <c:formatCode>General</c:formatCode>
                <c:ptCount val="4"/>
                <c:pt idx="0">
                  <c:v>3680</c:v>
                </c:pt>
                <c:pt idx="1">
                  <c:v>3906.6666666666501</c:v>
                </c:pt>
                <c:pt idx="2">
                  <c:v>4243.3333333333303</c:v>
                </c:pt>
                <c:pt idx="3">
                  <c:v>4906.6666666667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FC-40B8-A92D-0B3982CC436D}"/>
            </c:ext>
          </c:extLst>
        </c:ser>
        <c:ser>
          <c:idx val="1"/>
          <c:order val="1"/>
          <c:tx>
            <c:strRef>
              <c:f>PBMCs</c:f>
              <c:strCache>
                <c:ptCount val="1"/>
                <c:pt idx="0">
                  <c:v>PBMC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3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A5FC-40B8-A92D-0B3982CC436D}"/>
              </c:ext>
            </c:extLst>
          </c:dPt>
          <c:errBars>
            <c:errBarType val="both"/>
            <c:errValType val="cust"/>
            <c:noEndCap val="0"/>
            <c:plus>
              <c:numRef>
                <c:f>'284'!$M$8:$M$11</c:f>
                <c:numCache>
                  <c:formatCode>General</c:formatCode>
                  <c:ptCount val="4"/>
                  <c:pt idx="0">
                    <c:v>262.29754097207802</c:v>
                  </c:pt>
                  <c:pt idx="1">
                    <c:v>275.92269448766399</c:v>
                  </c:pt>
                  <c:pt idx="2">
                    <c:v>213.77558326431699</c:v>
                  </c:pt>
                  <c:pt idx="3">
                    <c:v>706.91819422994899</c:v>
                  </c:pt>
                </c:numCache>
              </c:numRef>
            </c:plus>
            <c:minus>
              <c:numRef>
                <c:f>'284'!$M$8:$M$11</c:f>
                <c:numCache>
                  <c:formatCode>General</c:formatCode>
                  <c:ptCount val="4"/>
                  <c:pt idx="0">
                    <c:v>262.29754097207802</c:v>
                  </c:pt>
                  <c:pt idx="1">
                    <c:v>275.92269448766399</c:v>
                  </c:pt>
                  <c:pt idx="2">
                    <c:v>213.77558326431699</c:v>
                  </c:pt>
                  <c:pt idx="3">
                    <c:v>706.918194229948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'284'!$B$8:$B$11</c:f>
              <c:numCache>
                <c:formatCode>General</c:formatCode>
                <c:ptCount val="4"/>
                <c:pt idx="0">
                  <c:v>0</c:v>
                </c:pt>
                <c:pt idx="1">
                  <c:v>5000</c:v>
                </c:pt>
                <c:pt idx="2">
                  <c:v>10000</c:v>
                </c:pt>
                <c:pt idx="3">
                  <c:v>20000</c:v>
                </c:pt>
              </c:numCache>
            </c:numRef>
          </c:cat>
          <c:val>
            <c:numRef>
              <c:f>'284'!$L$8:$L$11</c:f>
              <c:numCache>
                <c:formatCode>General</c:formatCode>
                <c:ptCount val="4"/>
                <c:pt idx="0">
                  <c:v>3680</c:v>
                </c:pt>
                <c:pt idx="1">
                  <c:v>3706.6666666666501</c:v>
                </c:pt>
                <c:pt idx="2">
                  <c:v>3810</c:v>
                </c:pt>
                <c:pt idx="3">
                  <c:v>3906.6666666666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5FC-40B8-A92D-0B3982CC43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47260624"/>
        <c:axId val="146877664"/>
      </c:barChart>
      <c:catAx>
        <c:axId val="147260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877664"/>
        <c:crosses val="autoZero"/>
        <c:auto val="1"/>
        <c:lblAlgn val="ctr"/>
        <c:lblOffset val="100"/>
        <c:noMultiLvlLbl val="0"/>
      </c:catAx>
      <c:valAx>
        <c:axId val="14687766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72606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1178089870675202"/>
          <c:y val="0.119206143306213"/>
          <c:w val="0.48557987033955402"/>
          <c:h val="0.12188097633170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sz="9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35597837336601"/>
          <c:y val="0.162300889446892"/>
          <c:w val="0.74454645330438096"/>
          <c:h val="0.6313820738168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HDFs</c:f>
              <c:strCache>
                <c:ptCount val="1"/>
                <c:pt idx="0">
                  <c:v>NHDFs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84'!$G$28:$G$31</c:f>
                <c:numCache>
                  <c:formatCode>General</c:formatCode>
                  <c:ptCount val="4"/>
                  <c:pt idx="0">
                    <c:v>332.46553706110899</c:v>
                  </c:pt>
                  <c:pt idx="1">
                    <c:v>160.93476939431</c:v>
                  </c:pt>
                  <c:pt idx="2">
                    <c:v>318.956632370818</c:v>
                  </c:pt>
                  <c:pt idx="3">
                    <c:v>417.97129088012701</c:v>
                  </c:pt>
                </c:numCache>
              </c:numRef>
            </c:plus>
            <c:minus>
              <c:numRef>
                <c:f>'284'!$G$28:$G$31</c:f>
                <c:numCache>
                  <c:formatCode>General</c:formatCode>
                  <c:ptCount val="4"/>
                  <c:pt idx="0">
                    <c:v>332.46553706110899</c:v>
                  </c:pt>
                  <c:pt idx="1">
                    <c:v>160.93476939431</c:v>
                  </c:pt>
                  <c:pt idx="2">
                    <c:v>318.956632370818</c:v>
                  </c:pt>
                  <c:pt idx="3">
                    <c:v>417.971290880127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'284'!$B$8:$B$11</c:f>
              <c:numCache>
                <c:formatCode>General</c:formatCode>
                <c:ptCount val="4"/>
                <c:pt idx="0">
                  <c:v>0</c:v>
                </c:pt>
                <c:pt idx="1">
                  <c:v>5000</c:v>
                </c:pt>
                <c:pt idx="2">
                  <c:v>10000</c:v>
                </c:pt>
                <c:pt idx="3">
                  <c:v>20000</c:v>
                </c:pt>
              </c:numCache>
            </c:numRef>
          </c:cat>
          <c:val>
            <c:numRef>
              <c:f>'284'!$F$28:$F$31</c:f>
              <c:numCache>
                <c:formatCode>General</c:formatCode>
                <c:ptCount val="4"/>
                <c:pt idx="0">
                  <c:v>4213.3333333333303</c:v>
                </c:pt>
                <c:pt idx="1">
                  <c:v>3730</c:v>
                </c:pt>
                <c:pt idx="2">
                  <c:v>4206.6666666667297</c:v>
                </c:pt>
                <c:pt idx="3">
                  <c:v>549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4E-40B6-AC26-A550E74D7AEF}"/>
            </c:ext>
          </c:extLst>
        </c:ser>
        <c:ser>
          <c:idx val="1"/>
          <c:order val="1"/>
          <c:tx>
            <c:strRef>
              <c:f>PBMCs</c:f>
              <c:strCache>
                <c:ptCount val="1"/>
                <c:pt idx="0">
                  <c:v>PBMCs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84'!$M$28:$M$31</c:f>
                <c:numCache>
                  <c:formatCode>General</c:formatCode>
                  <c:ptCount val="4"/>
                  <c:pt idx="0">
                    <c:v>332.46553706110899</c:v>
                  </c:pt>
                  <c:pt idx="1">
                    <c:v>176.72954855748799</c:v>
                  </c:pt>
                  <c:pt idx="2">
                    <c:v>150.44378795195701</c:v>
                  </c:pt>
                  <c:pt idx="3">
                    <c:v>64.291005073286399</c:v>
                  </c:pt>
                </c:numCache>
              </c:numRef>
            </c:plus>
            <c:minus>
              <c:numRef>
                <c:f>'284'!$M$28:$M$31</c:f>
                <c:numCache>
                  <c:formatCode>General</c:formatCode>
                  <c:ptCount val="4"/>
                  <c:pt idx="0">
                    <c:v>332.46553706110899</c:v>
                  </c:pt>
                  <c:pt idx="1">
                    <c:v>176.72954855748799</c:v>
                  </c:pt>
                  <c:pt idx="2">
                    <c:v>150.44378795195701</c:v>
                  </c:pt>
                  <c:pt idx="3">
                    <c:v>64.2910050732863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'284'!$B$8:$B$11</c:f>
              <c:numCache>
                <c:formatCode>General</c:formatCode>
                <c:ptCount val="4"/>
                <c:pt idx="0">
                  <c:v>0</c:v>
                </c:pt>
                <c:pt idx="1">
                  <c:v>5000</c:v>
                </c:pt>
                <c:pt idx="2">
                  <c:v>10000</c:v>
                </c:pt>
                <c:pt idx="3">
                  <c:v>20000</c:v>
                </c:pt>
              </c:numCache>
            </c:numRef>
          </c:cat>
          <c:val>
            <c:numRef>
              <c:f>'284'!$L$28:$L$31</c:f>
              <c:numCache>
                <c:formatCode>General</c:formatCode>
                <c:ptCount val="4"/>
                <c:pt idx="0">
                  <c:v>4213.3333333333303</c:v>
                </c:pt>
                <c:pt idx="1">
                  <c:v>4006.6666666666501</c:v>
                </c:pt>
                <c:pt idx="2">
                  <c:v>4696.6666666667297</c:v>
                </c:pt>
                <c:pt idx="3">
                  <c:v>5026.6666666667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4E-40B6-AC26-A550E74D7A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46454312"/>
        <c:axId val="148552728"/>
      </c:barChart>
      <c:catAx>
        <c:axId val="1464543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552728"/>
        <c:crosses val="autoZero"/>
        <c:auto val="1"/>
        <c:lblAlgn val="ctr"/>
        <c:lblOffset val="100"/>
        <c:noMultiLvlLbl val="0"/>
      </c:catAx>
      <c:valAx>
        <c:axId val="14855272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454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MY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DCF59D-A455-4455-9255-F234A60AEA7F}" type="datetimeFigureOut">
              <a:rPr lang="en-MY" smtClean="0"/>
              <a:t>15/4/2019</a:t>
            </a:fld>
            <a:endParaRPr lang="en-MY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MY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6F327B-117E-4541-90F5-D88BEF3E3B97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0386944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MY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6F327B-117E-4541-90F5-D88BEF3E3B97}" type="slidenum">
              <a:rPr lang="en-MY" smtClean="0"/>
              <a:t>1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0876881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0F021-1274-47D2-AFB4-0EE6EC0B1E33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72A7-9A5D-4E98-845A-D0069E1C6B40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C581F-F929-44D6-A4CE-8F76130C8A54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98D11-9C37-461D-B76B-EFCBB1704881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79D7-8623-4FAA-AC6D-0C7555325C6A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C212A-426F-4445-BFB7-8BD5D91CDD04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A0040-B0A6-418F-8278-AEDD500E1F0D}" type="datetime1">
              <a:rPr lang="en-US" smtClean="0"/>
              <a:t>4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6D794-079F-4B44-A7C3-68E3BA215814}" type="datetime1">
              <a:rPr lang="en-US" smtClean="0"/>
              <a:t>4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6ABCD-F7FF-47DE-A90E-574F763FE900}" type="datetime1">
              <a:rPr lang="en-US" smtClean="0"/>
              <a:t>4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B0F0F-09D8-408F-B710-8B995EEBC957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643E9-AB3F-4C16-8F61-3D81199BDB44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BCF2E-4AE9-41F0-A139-1AF658B2506B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1524000" y="4572000"/>
            <a:ext cx="381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666875" y="1123950"/>
            <a:ext cx="141922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910764" y="4657923"/>
            <a:ext cx="1403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400" dirty="0" smtClean="0"/>
              <a:t>Cell </a:t>
            </a:r>
            <a:r>
              <a:rPr lang="en-MY" sz="1400" dirty="0"/>
              <a:t>number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04825" y="1327150"/>
            <a:ext cx="400110" cy="27178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MY" sz="1400" b="1" dirty="0"/>
              <a:t>Relative luminescence </a:t>
            </a:r>
            <a:r>
              <a:rPr lang="en-MY" sz="1400" b="1" dirty="0" smtClean="0"/>
              <a:t>unit </a:t>
            </a:r>
            <a:r>
              <a:rPr lang="en-MY" sz="1400" b="1" dirty="0"/>
              <a:t>(</a:t>
            </a:r>
            <a:r>
              <a:rPr lang="en-MY" sz="1400" b="1" dirty="0" smtClean="0"/>
              <a:t>RLU) </a:t>
            </a:r>
            <a:endParaRPr lang="en-MY" sz="1400" b="1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5676900" y="1333500"/>
            <a:ext cx="0" cy="1143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676840" y="1276350"/>
            <a:ext cx="400110" cy="3200400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MY" sz="1400" b="1" dirty="0"/>
              <a:t>      2D model                        3D model                                          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903673" y="1314450"/>
            <a:ext cx="0" cy="2819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903673" y="1221059"/>
            <a:ext cx="405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  <a:endParaRPr lang="en-MY" sz="14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913198" y="2808386"/>
            <a:ext cx="405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  <a:endParaRPr lang="en-MY" sz="1400" b="1" dirty="0"/>
          </a:p>
        </p:txBody>
      </p:sp>
      <p:cxnSp>
        <p:nvCxnSpPr>
          <p:cNvPr id="45" name="Straight Connector 44"/>
          <p:cNvCxnSpPr/>
          <p:nvPr/>
        </p:nvCxnSpPr>
        <p:spPr>
          <a:xfrm flipV="1">
            <a:off x="3733800" y="1104900"/>
            <a:ext cx="16002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619250" y="797123"/>
            <a:ext cx="198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400" b="1" dirty="0"/>
              <a:t>XenoB110-gfp-luc2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844895" y="797123"/>
            <a:ext cx="198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400" b="1" dirty="0"/>
              <a:t>Xeno284-gfp-luc2</a:t>
            </a:r>
          </a:p>
        </p:txBody>
      </p:sp>
      <p:cxnSp>
        <p:nvCxnSpPr>
          <p:cNvPr id="39" name="Straight Connector 38"/>
          <p:cNvCxnSpPr/>
          <p:nvPr/>
        </p:nvCxnSpPr>
        <p:spPr>
          <a:xfrm>
            <a:off x="5676900" y="2990850"/>
            <a:ext cx="0" cy="1143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3" name="Chart 22"/>
          <p:cNvGraphicFramePr/>
          <p:nvPr/>
        </p:nvGraphicFramePr>
        <p:xfrm>
          <a:off x="1214003" y="1211534"/>
          <a:ext cx="2081647" cy="15192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Chart 24"/>
          <p:cNvGraphicFramePr/>
          <p:nvPr/>
        </p:nvGraphicFramePr>
        <p:xfrm>
          <a:off x="1252104" y="2770188"/>
          <a:ext cx="2037196" cy="16144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7" name="Chart 26"/>
          <p:cNvGraphicFramePr/>
          <p:nvPr/>
        </p:nvGraphicFramePr>
        <p:xfrm>
          <a:off x="3454400" y="1123950"/>
          <a:ext cx="2119312" cy="16844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8" name="Chart 27"/>
          <p:cNvGraphicFramePr/>
          <p:nvPr/>
        </p:nvGraphicFramePr>
        <p:xfrm>
          <a:off x="3481388" y="2699657"/>
          <a:ext cx="2195452" cy="18128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18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Dr. Ronald Teow Sin Yeang</cp:lastModifiedBy>
  <cp:revision>641</cp:revision>
  <dcterms:created xsi:type="dcterms:W3CDTF">2006-08-16T00:00:00Z</dcterms:created>
  <dcterms:modified xsi:type="dcterms:W3CDTF">2019-04-15T09:45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7439</vt:lpwstr>
  </property>
</Properties>
</file>